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37F76-C6DA-4FEF-B55B-DDA3E07260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678E8-CCB3-4460-A2A0-74F5DC6F57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384F7-22B2-41A9-95CE-14DF419799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FEF04-9E7F-46C1-B9FB-DEFF35EF9E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DA95F-F9FF-49F8-9C54-46259C44D3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47A66-9105-4E64-957E-54E6E78751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5B217-C1B5-4F63-91C2-D991E3ABC4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CC7179-4EC6-4136-8E18-6F34052DED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273E5-F567-4115-81BE-6C73AA2090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7B800-652A-4C5F-BAD1-6141F7FBEC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9A887-5070-416F-B75F-F8E652AB02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61792-D855-41CE-91EF-6AFE7AD169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910598D-7A6E-4005-81AC-A374D09D4AE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-360" y="-360"/>
            <a:ext cx="2057400" cy="304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bl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2378160" y="762120"/>
            <a:ext cx="4556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ble S4: Statistical analysis of the effects of the combination drug treatment on acinar diamet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Object 63"/>
          <p:cNvGraphicFramePr/>
          <p:nvPr/>
        </p:nvGraphicFramePr>
        <p:xfrm>
          <a:off x="990720" y="1143000"/>
          <a:ext cx="5952960" cy="19875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Object 6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90720" y="1143000"/>
                    <a:ext cx="5952960" cy="198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1T16:50:30Z</dcterms:created>
  <dc:creator>Khandan Keyomarsi</dc:creator>
  <dc:description/>
  <dc:language>en-US</dc:language>
  <cp:lastModifiedBy>Khandan Keyomarsi</cp:lastModifiedBy>
  <dcterms:modified xsi:type="dcterms:W3CDTF">2012-02-01T22:18:42Z</dcterms:modified>
  <cp:revision>2</cp:revision>
  <dc:subject/>
  <dc:title>Table S4 &amp; S5</dc:title>
</cp:coreProperties>
</file>